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8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ebecca\Documents\cuk%20seq%20data\0-16+peel.RG2.CucSa_BLAST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ebecca\Documents\cuk%20seq%20data\0-16+peel.RG2.CucSa_BLAST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5875">
              <a:solidFill>
                <a:schemeClr val="tx1"/>
              </a:solidFill>
            </a:ln>
          </c:spPr>
          <c:marker>
            <c:spPr>
              <a:ln>
                <a:solidFill>
                  <a:schemeClr val="tx1"/>
                </a:solidFill>
              </a:ln>
            </c:spPr>
          </c:marker>
          <c:xVal>
            <c:numRef>
              <c:f>'contig# length'!$Y$28:$Y$41</c:f>
              <c:numCache>
                <c:formatCode>General</c:formatCode>
                <c:ptCount val="14"/>
                <c:pt idx="0">
                  <c:v>2</c:v>
                </c:pt>
                <c:pt idx="1">
                  <c:v>1.9542425094393265</c:v>
                </c:pt>
                <c:pt idx="2">
                  <c:v>1.9030899869919446</c:v>
                </c:pt>
                <c:pt idx="3">
                  <c:v>1.845098040014256</c:v>
                </c:pt>
                <c:pt idx="4">
                  <c:v>1.7781512503836436</c:v>
                </c:pt>
                <c:pt idx="5">
                  <c:v>1.6989700043360203</c:v>
                </c:pt>
                <c:pt idx="6">
                  <c:v>1.6020599913279623</c:v>
                </c:pt>
                <c:pt idx="7">
                  <c:v>1.4771212547196606</c:v>
                </c:pt>
                <c:pt idx="8">
                  <c:v>1.3010299956639804</c:v>
                </c:pt>
                <c:pt idx="9">
                  <c:v>1</c:v>
                </c:pt>
                <c:pt idx="10">
                  <c:v>0.6989700043360193</c:v>
                </c:pt>
                <c:pt idx="11">
                  <c:v>0.47712125471966266</c:v>
                </c:pt>
                <c:pt idx="12">
                  <c:v>0.30102999566398148</c:v>
                </c:pt>
                <c:pt idx="13">
                  <c:v>0</c:v>
                </c:pt>
              </c:numCache>
            </c:numRef>
          </c:xVal>
          <c:yVal>
            <c:numRef>
              <c:f>'contig# length'!$Z$28:$Z$41</c:f>
              <c:numCache>
                <c:formatCode>General</c:formatCode>
                <c:ptCount val="14"/>
                <c:pt idx="0">
                  <c:v>0.96580918267665261</c:v>
                </c:pt>
                <c:pt idx="1">
                  <c:v>0.97435897435897489</c:v>
                </c:pt>
                <c:pt idx="2">
                  <c:v>0.97883597883597884</c:v>
                </c:pt>
                <c:pt idx="3">
                  <c:v>0.98230088495575163</c:v>
                </c:pt>
                <c:pt idx="4">
                  <c:v>0.98598516075844966</c:v>
                </c:pt>
                <c:pt idx="5">
                  <c:v>0.96479791395045678</c:v>
                </c:pt>
                <c:pt idx="6">
                  <c:v>0.97755491881566359</c:v>
                </c:pt>
                <c:pt idx="7">
                  <c:v>0.96363636363636351</c:v>
                </c:pt>
                <c:pt idx="8">
                  <c:v>0.94406280667320952</c:v>
                </c:pt>
                <c:pt idx="9">
                  <c:v>0.90064935064935114</c:v>
                </c:pt>
                <c:pt idx="10">
                  <c:v>0.80777912832088972</c:v>
                </c:pt>
                <c:pt idx="11">
                  <c:v>0.68489813994685567</c:v>
                </c:pt>
                <c:pt idx="12">
                  <c:v>0.56199075093591722</c:v>
                </c:pt>
                <c:pt idx="13">
                  <c:v>0.3660273529173748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107784"/>
        <c:axId val="81108176"/>
      </c:scatterChart>
      <c:valAx>
        <c:axId val="811077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81108176"/>
        <c:crosses val="autoZero"/>
        <c:crossBetween val="midCat"/>
      </c:valAx>
      <c:valAx>
        <c:axId val="81108176"/>
        <c:scaling>
          <c:orientation val="minMax"/>
          <c:max val="1.2"/>
        </c:scaling>
        <c:delete val="0"/>
        <c:axPos val="l"/>
        <c:numFmt formatCode="General" sourceLinked="1"/>
        <c:majorTickMark val="out"/>
        <c:minorTickMark val="none"/>
        <c:tickLblPos val="nextTo"/>
        <c:crossAx val="8110778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520424637641956"/>
          <c:y val="5.1400554097404488E-2"/>
          <c:w val="0.77830090826275578"/>
          <c:h val="0.8326195683872849"/>
        </c:manualLayout>
      </c:layout>
      <c:scatterChart>
        <c:scatterStyle val="lineMarker"/>
        <c:varyColors val="0"/>
        <c:ser>
          <c:idx val="0"/>
          <c:order val="0"/>
          <c:spPr>
            <a:ln w="19050">
              <a:solidFill>
                <a:schemeClr val="tx1"/>
              </a:solidFill>
            </a:ln>
          </c:spPr>
          <c:marker>
            <c:spPr>
              <a:ln>
                <a:solidFill>
                  <a:schemeClr val="tx1"/>
                </a:solidFill>
              </a:ln>
            </c:spPr>
          </c:marker>
          <c:xVal>
            <c:numRef>
              <c:f>'contig# length'!$AC$28:$AC$41</c:f>
              <c:numCache>
                <c:formatCode>General</c:formatCode>
                <c:ptCount val="14"/>
                <c:pt idx="0">
                  <c:v>2</c:v>
                </c:pt>
                <c:pt idx="1">
                  <c:v>1.9542425094393265</c:v>
                </c:pt>
                <c:pt idx="2">
                  <c:v>1.9030899869919446</c:v>
                </c:pt>
                <c:pt idx="3">
                  <c:v>1.845098040014256</c:v>
                </c:pt>
                <c:pt idx="4">
                  <c:v>1.7781512503836436</c:v>
                </c:pt>
                <c:pt idx="5">
                  <c:v>1.6989700043360203</c:v>
                </c:pt>
                <c:pt idx="6">
                  <c:v>1.6020599913279623</c:v>
                </c:pt>
                <c:pt idx="7">
                  <c:v>1.4771212547196606</c:v>
                </c:pt>
                <c:pt idx="8">
                  <c:v>1.3010299956639804</c:v>
                </c:pt>
                <c:pt idx="9">
                  <c:v>1</c:v>
                </c:pt>
                <c:pt idx="10">
                  <c:v>0.6989700043360193</c:v>
                </c:pt>
                <c:pt idx="11">
                  <c:v>0.47712125471966266</c:v>
                </c:pt>
                <c:pt idx="12">
                  <c:v>0.30102999566398148</c:v>
                </c:pt>
                <c:pt idx="13">
                  <c:v>0</c:v>
                </c:pt>
              </c:numCache>
            </c:numRef>
          </c:xVal>
          <c:yVal>
            <c:numRef>
              <c:f>'contig# length'!$AD$28:$AD$41</c:f>
              <c:numCache>
                <c:formatCode>General</c:formatCode>
                <c:ptCount val="14"/>
                <c:pt idx="0">
                  <c:v>1548</c:v>
                </c:pt>
                <c:pt idx="1">
                  <c:v>1669</c:v>
                </c:pt>
                <c:pt idx="2">
                  <c:v>1571</c:v>
                </c:pt>
                <c:pt idx="3">
                  <c:v>1546</c:v>
                </c:pt>
                <c:pt idx="4">
                  <c:v>1610</c:v>
                </c:pt>
                <c:pt idx="5">
                  <c:v>1534</c:v>
                </c:pt>
                <c:pt idx="6">
                  <c:v>1526</c:v>
                </c:pt>
                <c:pt idx="7">
                  <c:v>1451</c:v>
                </c:pt>
                <c:pt idx="8">
                  <c:v>1312</c:v>
                </c:pt>
                <c:pt idx="9">
                  <c:v>1076</c:v>
                </c:pt>
                <c:pt idx="10">
                  <c:v>784</c:v>
                </c:pt>
                <c:pt idx="11">
                  <c:v>582</c:v>
                </c:pt>
                <c:pt idx="12">
                  <c:v>450</c:v>
                </c:pt>
                <c:pt idx="13">
                  <c:v>30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642824"/>
        <c:axId val="81642432"/>
      </c:scatterChart>
      <c:valAx>
        <c:axId val="81642824"/>
        <c:scaling>
          <c:orientation val="minMax"/>
          <c:max val="2.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crossAx val="81642432"/>
        <c:crosses val="autoZero"/>
        <c:crossBetween val="midCat"/>
        <c:majorUnit val="0.5"/>
      </c:valAx>
      <c:valAx>
        <c:axId val="81642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8164282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933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004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285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375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532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506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230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377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807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343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335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060773-4564-46D0-B3AE-6EEB95E7900E}" type="datetimeFigureOut">
              <a:rPr lang="en-US" smtClean="0"/>
              <a:t>4/1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79276C-7628-4624-BD96-13CE6BA75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2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95998" y="504825"/>
            <a:ext cx="5952452" cy="2943999"/>
            <a:chOff x="495973" y="4114800"/>
            <a:chExt cx="5952452" cy="2943999"/>
          </a:xfrm>
        </p:grpSpPr>
        <p:graphicFrame>
          <p:nvGraphicFramePr>
            <p:cNvPr id="3" name="Chart 2"/>
            <p:cNvGraphicFramePr/>
            <p:nvPr>
              <p:extLst/>
            </p:nvPr>
          </p:nvGraphicFramePr>
          <p:xfrm>
            <a:off x="3733800" y="4114800"/>
            <a:ext cx="271462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/>
            <p:cNvGraphicFramePr/>
            <p:nvPr>
              <p:extLst/>
            </p:nvPr>
          </p:nvGraphicFramePr>
          <p:xfrm>
            <a:off x="685800" y="4114800"/>
            <a:ext cx="28956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4143460" y="6781800"/>
              <a:ext cx="21392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No. ESTs per transcript (log10) </a:t>
              </a:r>
              <a:endParaRPr lang="en-US" sz="12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244100" y="6778823"/>
              <a:ext cx="21392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No. ESTs per transcript (log10) </a:t>
              </a:r>
              <a:endParaRPr lang="en-US" sz="1200" dirty="0"/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2649681" y="5174437"/>
              <a:ext cx="19569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% transcripts with </a:t>
              </a:r>
              <a:r>
                <a:rPr lang="en-US" sz="1200" dirty="0" err="1" smtClean="0"/>
                <a:t>homologs</a:t>
              </a:r>
              <a:endParaRPr lang="en-US" sz="1200" dirty="0"/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-261285" y="5116336"/>
              <a:ext cx="17915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Average transcript length</a:t>
              </a:r>
              <a:endParaRPr lang="en-US" sz="1200" dirty="0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230092" y="3716829"/>
            <a:ext cx="87329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S1</a:t>
            </a:r>
            <a:r>
              <a:rPr lang="en-US" sz="1200" dirty="0"/>
              <a:t>. </a:t>
            </a:r>
            <a:r>
              <a:rPr lang="en-US" sz="1200" dirty="0" smtClean="0"/>
              <a:t>Relationship </a:t>
            </a:r>
            <a:r>
              <a:rPr lang="en-US" sz="1200" dirty="0"/>
              <a:t>between number of ESTs per </a:t>
            </a:r>
            <a:r>
              <a:rPr lang="en-US" sz="1200" dirty="0" err="1"/>
              <a:t>contig</a:t>
            </a:r>
            <a:r>
              <a:rPr lang="en-US" sz="1200" dirty="0"/>
              <a:t> and mean </a:t>
            </a:r>
            <a:r>
              <a:rPr lang="en-US" sz="1200" dirty="0" err="1"/>
              <a:t>contig</a:t>
            </a:r>
            <a:r>
              <a:rPr lang="en-US" sz="1200" dirty="0"/>
              <a:t> length </a:t>
            </a:r>
            <a:r>
              <a:rPr lang="en-US" sz="1200" dirty="0" smtClean="0"/>
              <a:t>(A) or </a:t>
            </a:r>
            <a:r>
              <a:rPr lang="en-US" sz="1200" dirty="0"/>
              <a:t>% of </a:t>
            </a:r>
            <a:r>
              <a:rPr lang="en-US" sz="1200" dirty="0" err="1"/>
              <a:t>contigs</a:t>
            </a:r>
            <a:r>
              <a:rPr lang="en-US" sz="1200" dirty="0"/>
              <a:t> with homologs in </a:t>
            </a:r>
            <a:r>
              <a:rPr lang="en-US" sz="1200" dirty="0" smtClean="0"/>
              <a:t>Arabidopsis (B).  </a:t>
            </a:r>
            <a:endParaRPr lang="en-US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439501" y="50482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4346595" y="50114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7785185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54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</dc:creator>
  <cp:lastModifiedBy>Rebecca</cp:lastModifiedBy>
  <cp:revision>2</cp:revision>
  <dcterms:created xsi:type="dcterms:W3CDTF">2014-04-12T19:02:26Z</dcterms:created>
  <dcterms:modified xsi:type="dcterms:W3CDTF">2014-04-15T13:48:53Z</dcterms:modified>
</cp:coreProperties>
</file>